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53246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85965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33620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411284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76963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75345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72145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2862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52349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03823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01639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r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E13CC-A9C7-4B77-9DE1-8D758E4A71E7}" type="datetimeFigureOut">
              <a:rPr lang="fr-CH" smtClean="0"/>
              <a:t>03.05.2021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06F39-8784-4A6B-8C9F-51A99345E28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36776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0938" y="2414877"/>
            <a:ext cx="3599695" cy="359969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3092334" y="2842953"/>
            <a:ext cx="332509" cy="12469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>
            <a:off x="3092334" y="3045230"/>
            <a:ext cx="332509" cy="124690"/>
          </a:xfrm>
          <a:prstGeom prst="rect">
            <a:avLst/>
          </a:prstGeom>
          <a:solidFill>
            <a:srgbClr val="ECD844"/>
          </a:solidFill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/>
          <p:cNvSpPr/>
          <p:nvPr/>
        </p:nvSpPr>
        <p:spPr>
          <a:xfrm>
            <a:off x="3092334" y="3247506"/>
            <a:ext cx="332509" cy="124690"/>
          </a:xfrm>
          <a:prstGeom prst="rect">
            <a:avLst/>
          </a:prstGeom>
          <a:solidFill>
            <a:srgbClr val="72BE9A"/>
          </a:solidFill>
          <a:ln>
            <a:solidFill>
              <a:srgbClr val="45876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57750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8563429" y="10060"/>
            <a:ext cx="157446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H" b="1" dirty="0">
                <a:latin typeface="Helvetica" panose="020B0604020202020204" pitchFamily="34" charset="0"/>
                <a:cs typeface="Helvetica" panose="020B0604020202020204" pitchFamily="34" charset="0"/>
              </a:rPr>
              <a:t>MT-</a:t>
            </a:r>
            <a:r>
              <a:rPr lang="fr-CH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weighted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687140" y="8225"/>
            <a:ext cx="18558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H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1-weighted</a:t>
            </a:r>
            <a:endParaRPr lang="en-GB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2000" y="2304000"/>
            <a:ext cx="1889428" cy="18894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4000" y="504000"/>
            <a:ext cx="1889428" cy="188942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5174" y="504000"/>
            <a:ext cx="1899028" cy="189902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4000" y="2304000"/>
            <a:ext cx="1889428" cy="188942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5174" y="2304000"/>
            <a:ext cx="1889428" cy="188942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000" y="504000"/>
            <a:ext cx="1889428" cy="188942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2000" y="504000"/>
            <a:ext cx="1899028" cy="189902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000" y="2304000"/>
            <a:ext cx="1889428" cy="188942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429" y="4378717"/>
            <a:ext cx="4043506" cy="242743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7017" y="4364199"/>
            <a:ext cx="4043506" cy="2427434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305200" y="403930"/>
            <a:ext cx="14960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OL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114935" y="409684"/>
            <a:ext cx="158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L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132683" y="411187"/>
            <a:ext cx="14960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OL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9942418" y="416941"/>
            <a:ext cx="158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LS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-5400000">
            <a:off x="35199" y="1225735"/>
            <a:ext cx="14960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Grey </a:t>
            </a:r>
            <a:r>
              <a:rPr lang="en-GB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</a:p>
        </p:txBody>
      </p:sp>
      <p:sp>
        <p:nvSpPr>
          <p:cNvPr id="27" name="TextBox 26"/>
          <p:cNvSpPr txBox="1"/>
          <p:nvPr/>
        </p:nvSpPr>
        <p:spPr>
          <a:xfrm rot="-5400000">
            <a:off x="133" y="3002232"/>
            <a:ext cx="158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White </a:t>
            </a:r>
            <a:r>
              <a:rPr lang="en-GB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</a:p>
        </p:txBody>
      </p:sp>
      <p:sp>
        <p:nvSpPr>
          <p:cNvPr id="28" name="TextBox 27"/>
          <p:cNvSpPr txBox="1"/>
          <p:nvPr/>
        </p:nvSpPr>
        <p:spPr>
          <a:xfrm rot="-5400000">
            <a:off x="5891709" y="1247515"/>
            <a:ext cx="14960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Grey </a:t>
            </a:r>
            <a:r>
              <a:rPr lang="en-GB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</a:p>
        </p:txBody>
      </p:sp>
      <p:sp>
        <p:nvSpPr>
          <p:cNvPr id="29" name="TextBox 28"/>
          <p:cNvSpPr txBox="1"/>
          <p:nvPr/>
        </p:nvSpPr>
        <p:spPr>
          <a:xfrm rot="-5400000">
            <a:off x="5856643" y="3024006"/>
            <a:ext cx="158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White </a:t>
            </a:r>
            <a:r>
              <a:rPr lang="en-GB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646286" y="4271984"/>
            <a:ext cx="14960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ey 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59336" y="4277738"/>
            <a:ext cx="158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hite 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473769" y="4264727"/>
            <a:ext cx="149606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Grey 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543277" y="4270481"/>
            <a:ext cx="15899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CH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White </a:t>
            </a:r>
            <a:r>
              <a:rPr lang="en-GB" sz="14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matter</a:t>
            </a:r>
            <a:endParaRPr lang="en-GB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41463" y="374329"/>
            <a:ext cx="2735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H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 </a:t>
            </a:r>
            <a:endParaRPr lang="en-GB" b="1" baseline="-25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441463" y="4216576"/>
            <a:ext cx="2735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H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 </a:t>
            </a:r>
            <a:endParaRPr lang="en-GB" b="1" baseline="-25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6239924" y="381588"/>
            <a:ext cx="2735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H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 </a:t>
            </a:r>
            <a:endParaRPr lang="en-GB" b="1" baseline="-25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6239924" y="4223835"/>
            <a:ext cx="273548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CH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 </a:t>
            </a:r>
            <a:endParaRPr lang="en-GB" b="1" baseline="-25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2733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</Words>
  <Application>Microsoft Office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tti Antoine</dc:creator>
  <cp:lastModifiedBy>Lutti Antoine</cp:lastModifiedBy>
  <cp:revision>1</cp:revision>
  <dcterms:created xsi:type="dcterms:W3CDTF">2021-05-03T15:27:59Z</dcterms:created>
  <dcterms:modified xsi:type="dcterms:W3CDTF">2021-05-03T15:28:11Z</dcterms:modified>
</cp:coreProperties>
</file>